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015" autoAdjust="0"/>
    <p:restoredTop sz="94660"/>
  </p:normalViewPr>
  <p:slideViewPr>
    <p:cSldViewPr snapToGrid="0">
      <p:cViewPr varScale="1">
        <p:scale>
          <a:sx n="89" d="100"/>
          <a:sy n="89" d="100"/>
        </p:scale>
        <p:origin x="120" y="1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130426"/>
            <a:ext cx="103632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28800" y="3886200"/>
            <a:ext cx="85344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53C5AD-EAFD-4CE1-9E83-917030A0AC5E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2/11/2015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A0C7D-4219-45CF-94A7-FC98AAF1D499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3428881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53C5AD-EAFD-4CE1-9E83-917030A0AC5E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2/11/2015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A0C7D-4219-45CF-94A7-FC98AAF1D499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3882745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839200" y="274639"/>
            <a:ext cx="27432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09600" y="274639"/>
            <a:ext cx="80264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53C5AD-EAFD-4CE1-9E83-917030A0AC5E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2/11/2015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A0C7D-4219-45CF-94A7-FC98AAF1D499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0771962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53C5AD-EAFD-4CE1-9E83-917030A0AC5E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2/11/2015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A0C7D-4219-45CF-94A7-FC98AAF1D499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340061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63084" y="4406901"/>
            <a:ext cx="103632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63084" y="2906713"/>
            <a:ext cx="103632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53C5AD-EAFD-4CE1-9E83-917030A0AC5E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2/11/2015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A0C7D-4219-45CF-94A7-FC98AAF1D499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87214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09600" y="1600201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97600" y="1600201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53C5AD-EAFD-4CE1-9E83-917030A0AC5E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2/11/2015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A0C7D-4219-45CF-94A7-FC98AAF1D499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2851220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0" y="1535113"/>
            <a:ext cx="5386917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09600" y="2174875"/>
            <a:ext cx="538691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93368" y="1535113"/>
            <a:ext cx="5389033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93368" y="2174875"/>
            <a:ext cx="5389033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53C5AD-EAFD-4CE1-9E83-917030A0AC5E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2/11/2015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A0C7D-4219-45CF-94A7-FC98AAF1D499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2532743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53C5AD-EAFD-4CE1-9E83-917030A0AC5E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2/11/2015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A0C7D-4219-45CF-94A7-FC98AAF1D499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740706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53C5AD-EAFD-4CE1-9E83-917030A0AC5E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2/11/2015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A0C7D-4219-45CF-94A7-FC98AAF1D499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211842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01" y="273050"/>
            <a:ext cx="4011084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766733" y="273051"/>
            <a:ext cx="6815667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09601" y="1435101"/>
            <a:ext cx="4011084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53C5AD-EAFD-4CE1-9E83-917030A0AC5E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2/11/2015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A0C7D-4219-45CF-94A7-FC98AAF1D499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9294541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389717" y="4800600"/>
            <a:ext cx="73152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389717" y="612775"/>
            <a:ext cx="73152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389717" y="5367338"/>
            <a:ext cx="73152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53C5AD-EAFD-4CE1-9E83-917030A0AC5E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2/11/2015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A0C7D-4219-45CF-94A7-FC98AAF1D499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550863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0" y="1600201"/>
            <a:ext cx="109728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09600" y="6356351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53C5AD-EAFD-4CE1-9E83-917030A0AC5E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2/11/2015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165600" y="6356351"/>
            <a:ext cx="3860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737600" y="6356351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5A0C7D-4219-45CF-94A7-FC98AAF1D499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9522200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Table 7"/>
          <p:cNvGraphicFramePr>
            <a:graphicFrameLocks noGrp="1"/>
          </p:cNvGraphicFramePr>
          <p:nvPr>
            <p:extLst/>
          </p:nvPr>
        </p:nvGraphicFramePr>
        <p:xfrm>
          <a:off x="1600200" y="609600"/>
          <a:ext cx="5753100" cy="5986144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835040"/>
                <a:gridCol w="1728687"/>
                <a:gridCol w="2189373"/>
              </a:tblGrid>
              <a:tr h="187067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 Name</a:t>
                      </a:r>
                      <a:endParaRPr lang="en-US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4" marR="5074" marT="507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g Avg. FC</a:t>
                      </a:r>
                      <a:endParaRPr lang="en-US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4" marR="5074" marT="507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west </a:t>
                      </a:r>
                      <a:r>
                        <a:rPr lang="en-US" sz="1000" b="1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-value among the 5 studies</a:t>
                      </a:r>
                      <a:endParaRPr lang="en-US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4" marR="5074" marT="5074" marB="0" anchor="b">
                    <a:noFill/>
                  </a:tcPr>
                </a:tc>
              </a:tr>
              <a:tr h="187067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RPINB4</a:t>
                      </a:r>
                      <a:endParaRPr lang="en-US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4" marR="5074" marT="507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277019432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4" marR="5074" marT="507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27 X10</a:t>
                      </a:r>
                      <a:r>
                        <a:rPr lang="en-US" sz="1000" baseline="30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9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4" marR="5074" marT="5074" marB="0" anchor="b">
                    <a:noFill/>
                  </a:tcPr>
                </a:tc>
              </a:tr>
              <a:tr h="187067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KR1B10</a:t>
                      </a:r>
                      <a:endParaRPr lang="en-US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4" marR="5074" marT="507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544774784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4" marR="5074" marT="507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4 X10</a:t>
                      </a:r>
                      <a:r>
                        <a:rPr lang="en-US" sz="1000" baseline="30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0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4" marR="5074" marT="5074" marB="0" anchor="b">
                    <a:noFill/>
                  </a:tcPr>
                </a:tc>
              </a:tr>
              <a:tr h="187067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RPINB3</a:t>
                      </a:r>
                      <a:endParaRPr lang="en-US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4" marR="5074" marT="507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646773884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4" marR="5074" marT="507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48 X10</a:t>
                      </a:r>
                      <a:r>
                        <a:rPr lang="en-US" sz="1000" baseline="30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1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4" marR="5074" marT="5074" marB="0" anchor="b">
                    <a:noFill/>
                  </a:tcPr>
                </a:tc>
              </a:tr>
              <a:tr h="187067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100A7</a:t>
                      </a:r>
                      <a:endParaRPr lang="en-US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4" marR="5074" marT="507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367522369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4" marR="5074" marT="507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28 X10</a:t>
                      </a:r>
                      <a:r>
                        <a:rPr lang="en-US" sz="1000" baseline="30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1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4" marR="5074" marT="5074" marB="0" anchor="b">
                    <a:noFill/>
                  </a:tcPr>
                </a:tc>
              </a:tr>
              <a:tr h="187067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FB4A</a:t>
                      </a:r>
                      <a:endParaRPr lang="en-US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4" marR="5074" marT="507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246248748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4" marR="5074" marT="507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000283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4" marR="5074" marT="5074" marB="0" anchor="b">
                    <a:noFill/>
                  </a:tcPr>
                </a:tc>
              </a:tr>
              <a:tr h="187067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RM2</a:t>
                      </a:r>
                      <a:endParaRPr lang="en-US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4" marR="5074" marT="507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096689214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4" marR="5074" marT="507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00124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4" marR="5074" marT="5074" marB="0" anchor="b">
                    <a:noFill/>
                  </a:tcPr>
                </a:tc>
              </a:tr>
              <a:tr h="187067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L18</a:t>
                      </a:r>
                      <a:endParaRPr lang="en-US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4" marR="5074" marT="507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005266306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4" marR="5074" marT="507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74 X10</a:t>
                      </a:r>
                      <a:r>
                        <a:rPr lang="en-US" sz="1000" baseline="30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9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4" marR="5074" marT="5074" marB="0" anchor="b">
                    <a:noFill/>
                  </a:tcPr>
                </a:tc>
              </a:tr>
              <a:tr h="187067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I3</a:t>
                      </a:r>
                      <a:endParaRPr lang="en-US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4" marR="5074" marT="507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003801065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4" marR="5074" marT="507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62 X10</a:t>
                      </a:r>
                      <a:r>
                        <a:rPr lang="en-US" sz="1000" baseline="30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8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4" marR="5074" marT="5074" marB="0" anchor="b">
                    <a:noFill/>
                  </a:tcPr>
                </a:tc>
              </a:tr>
              <a:tr h="187067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L6A6</a:t>
                      </a:r>
                      <a:endParaRPr lang="en-US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4" marR="5074" marT="507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902604864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4" marR="5074" marT="507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00717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4" marR="5074" marT="5074" marB="0" anchor="b">
                    <a:noFill/>
                  </a:tcPr>
                </a:tc>
              </a:tr>
              <a:tr h="187067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RT16</a:t>
                      </a:r>
                      <a:endParaRPr lang="en-US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4" marR="5074" marT="507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847253956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4" marR="5074" marT="507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87 X10</a:t>
                      </a:r>
                      <a:r>
                        <a:rPr lang="en-US" sz="1000" baseline="30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1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4" marR="5074" marT="5074" marB="0" anchor="b">
                    <a:noFill/>
                  </a:tcPr>
                </a:tc>
              </a:tr>
              <a:tr h="187067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100A8</a:t>
                      </a:r>
                      <a:endParaRPr lang="en-US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4" marR="5074" marT="507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444272634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4" marR="5074" marT="507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0487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4" marR="5074" marT="5074" marB="0" anchor="b">
                    <a:noFill/>
                  </a:tcPr>
                </a:tc>
              </a:tr>
              <a:tr h="187067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GS1</a:t>
                      </a:r>
                      <a:endParaRPr lang="en-US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4" marR="5074" marT="507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4171696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4" marR="5074" marT="507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03 X10</a:t>
                      </a:r>
                      <a:r>
                        <a:rPr lang="en-US" sz="1000" baseline="30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8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4" marR="5074" marT="5074" marB="0" anchor="b">
                    <a:noFill/>
                  </a:tcPr>
                </a:tc>
              </a:tr>
              <a:tr h="187067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L22</a:t>
                      </a:r>
                      <a:endParaRPr lang="en-US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4" marR="5074" marT="507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350973833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4" marR="5074" marT="507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00104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4" marR="5074" marT="5074" marB="0" anchor="b">
                    <a:noFill/>
                  </a:tcPr>
                </a:tc>
              </a:tr>
              <a:tr h="187067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CAPG</a:t>
                      </a:r>
                      <a:endParaRPr lang="en-US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4" marR="5074" marT="507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955770125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4" marR="5074" marT="507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91 X10</a:t>
                      </a:r>
                      <a:r>
                        <a:rPr lang="en-US" sz="1000" baseline="30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0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4" marR="5074" marT="5074" marB="0" anchor="b">
                    <a:noFill/>
                  </a:tcPr>
                </a:tc>
              </a:tr>
              <a:tr h="187067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MPRSS4</a:t>
                      </a:r>
                      <a:endParaRPr lang="en-US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4" marR="5074" marT="507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931612832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4" marR="5074" marT="507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142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4" marR="5074" marT="5074" marB="0" anchor="b">
                    <a:noFill/>
                  </a:tcPr>
                </a:tc>
              </a:tr>
              <a:tr h="187067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YNU</a:t>
                      </a:r>
                      <a:endParaRPr lang="en-US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4" marR="5074" marT="507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917508821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4" marR="5074" marT="507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000459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4" marR="5074" marT="5074" marB="0" anchor="b">
                    <a:noFill/>
                  </a:tcPr>
                </a:tc>
              </a:tr>
              <a:tr h="187067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RT6</a:t>
                      </a:r>
                      <a:endParaRPr lang="en-US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4" marR="5074" marT="507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767921956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4" marR="5074" marT="507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61 X10</a:t>
                      </a:r>
                      <a:r>
                        <a:rPr lang="en-US" sz="1000" baseline="30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0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4" marR="5074" marT="5074" marB="0" anchor="b">
                    <a:noFill/>
                  </a:tcPr>
                </a:tc>
              </a:tr>
              <a:tr h="187067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LE</a:t>
                      </a:r>
                      <a:endParaRPr lang="en-US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4" marR="5074" marT="507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446403227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4" marR="5074" marT="507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579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4" marR="5074" marT="5074" marB="0" anchor="b">
                    <a:noFill/>
                  </a:tcPr>
                </a:tc>
              </a:tr>
              <a:tr h="187067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LNT6</a:t>
                      </a:r>
                      <a:endParaRPr lang="en-US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4" marR="5074" marT="507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367450784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4" marR="5074" marT="507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78 X10</a:t>
                      </a:r>
                      <a:r>
                        <a:rPr lang="en-US" sz="1000" baseline="30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8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4" marR="5074" marT="5074" marB="0" anchor="b">
                    <a:noFill/>
                  </a:tcPr>
                </a:tc>
              </a:tr>
              <a:tr h="187067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GF</a:t>
                      </a:r>
                      <a:endParaRPr lang="en-US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4" marR="5074" marT="507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326221816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4" marR="5074" marT="507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39 X10</a:t>
                      </a:r>
                      <a:r>
                        <a:rPr lang="en-US" sz="1000" baseline="30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9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4" marR="5074" marT="5074" marB="0" anchor="b">
                    <a:noFill/>
                  </a:tcPr>
                </a:tc>
              </a:tr>
              <a:tr h="187067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L17</a:t>
                      </a:r>
                      <a:endParaRPr lang="en-US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4" marR="5074" marT="507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277567843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4" marR="5074" marT="507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29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4" marR="5074" marT="5074" marB="0" anchor="b">
                    <a:noFill/>
                  </a:tcPr>
                </a:tc>
              </a:tr>
              <a:tr h="187067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POBEC3A</a:t>
                      </a:r>
                      <a:endParaRPr lang="en-US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4" marR="5074" marT="507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247232971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4" marR="5074" marT="507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209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4" marR="5074" marT="5074" marB="0" anchor="b">
                    <a:noFill/>
                  </a:tcPr>
                </a:tc>
              </a:tr>
              <a:tr h="187067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YMP</a:t>
                      </a:r>
                      <a:endParaRPr lang="en-US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4" marR="5074" marT="507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09796741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4" marR="5074" marT="507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0058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4" marR="5074" marT="5074" marB="0" anchor="b">
                    <a:noFill/>
                  </a:tcPr>
                </a:tc>
              </a:tr>
              <a:tr h="187067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L27RA</a:t>
                      </a:r>
                      <a:endParaRPr lang="en-US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4" marR="5074" marT="507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043993933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4" marR="5074" marT="507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0027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4" marR="5074" marT="5074" marB="0" anchor="b">
                    <a:noFill/>
                  </a:tcPr>
                </a:tc>
              </a:tr>
              <a:tr h="187067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PR171</a:t>
                      </a:r>
                      <a:endParaRPr lang="en-US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4" marR="5074" marT="507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018769024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4" marR="5074" marT="507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34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4" marR="5074" marT="5074" marB="0" anchor="b">
                    <a:noFill/>
                  </a:tcPr>
                </a:tc>
              </a:tr>
              <a:tr h="187067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ZMB</a:t>
                      </a:r>
                      <a:endParaRPr lang="en-US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4" marR="5074" marT="507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982573983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4" marR="5074" marT="507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534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4" marR="5074" marT="5074" marB="0" anchor="b">
                    <a:noFill/>
                  </a:tcPr>
                </a:tc>
              </a:tr>
              <a:tr h="187067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HBP1L1</a:t>
                      </a:r>
                      <a:endParaRPr lang="en-US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4" marR="5074" marT="507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906204353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4" marR="5074" marT="507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00385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4" marR="5074" marT="5074" marB="0" anchor="b">
                    <a:noFill/>
                  </a:tcPr>
                </a:tc>
              </a:tr>
              <a:tr h="187067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ACC3</a:t>
                      </a:r>
                      <a:endParaRPr lang="en-US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4" marR="5074" marT="507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902825307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4" marR="5074" marT="507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000096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4" marR="5074" marT="5074" marB="0" anchor="b">
                    <a:noFill/>
                  </a:tcPr>
                </a:tc>
              </a:tr>
              <a:tr h="187067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BLC</a:t>
                      </a:r>
                      <a:endParaRPr lang="en-US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4" marR="5074" marT="507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838749796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4" marR="5074" marT="507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0767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4" marR="5074" marT="5074" marB="0" anchor="b">
                    <a:noFill/>
                  </a:tcPr>
                </a:tc>
              </a:tr>
              <a:tr h="187067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1B</a:t>
                      </a:r>
                      <a:endParaRPr lang="en-US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4" marR="5074" marT="507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709019751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4" marR="5074" marT="507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28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4" marR="5074" marT="5074" marB="0" anchor="b">
                    <a:noFill/>
                  </a:tcPr>
                </a:tc>
              </a:tr>
              <a:tr h="187067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GL</a:t>
                      </a:r>
                      <a:endParaRPr lang="en-US" sz="10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4" marR="5074" marT="507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76398326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4" marR="5074" marT="507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825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4" marR="5074" marT="5074" marB="0" anchor="b">
                    <a:noFill/>
                  </a:tcPr>
                </a:tc>
              </a:tr>
            </a:tbl>
          </a:graphicData>
        </a:graphic>
      </p:graphicFrame>
      <p:sp>
        <p:nvSpPr>
          <p:cNvPr id="9" name="TextBox 8"/>
          <p:cNvSpPr txBox="1"/>
          <p:nvPr/>
        </p:nvSpPr>
        <p:spPr>
          <a:xfrm>
            <a:off x="1828800" y="76200"/>
            <a:ext cx="7543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2</a:t>
            </a:r>
            <a:r>
              <a:rPr lang="en-US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Table: Up-regulated genes</a:t>
            </a:r>
            <a:endParaRPr lang="en-US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23286623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22</Words>
  <Application>Microsoft Office PowerPoint</Application>
  <PresentationFormat>Widescreen</PresentationFormat>
  <Paragraphs>9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1_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ouglas Surwilo</dc:creator>
  <cp:lastModifiedBy>Douglas Surwilo</cp:lastModifiedBy>
  <cp:revision>1</cp:revision>
  <dcterms:created xsi:type="dcterms:W3CDTF">2015-12-11T19:31:16Z</dcterms:created>
  <dcterms:modified xsi:type="dcterms:W3CDTF">2015-12-11T19:31:31Z</dcterms:modified>
</cp:coreProperties>
</file>